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brummer\Box\Rochester%20Box\Research\Excel%20data%20analysis\Data%20for%20graph%20figures,%20stratific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brummer\Box\Rochester%20Box\Research\Excel%20data%20analysis\Data%20for%20graph%20figures,%20stratific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cap="all" spc="120" normalizeH="0" baseline="0">
                <a:solidFill>
                  <a:schemeClr val="accent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aseline="0" dirty="0">
                <a:solidFill>
                  <a:schemeClr val="accent1">
                    <a:lumMod val="50000"/>
                  </a:schemeClr>
                </a:solidFill>
              </a:rPr>
              <a:t>Fever Days</a:t>
            </a:r>
          </a:p>
        </c:rich>
      </c:tx>
      <c:layout>
        <c:manualLayout>
          <c:xMode val="edge"/>
          <c:yMode val="edge"/>
          <c:x val="0.40789076611130265"/>
          <c:y val="1.205598152302170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cap="all" spc="120" normalizeH="0" baseline="0">
              <a:solidFill>
                <a:schemeClr val="accent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501905867541415"/>
          <c:y val="0.23136004960766465"/>
          <c:w val="0.80087685723233237"/>
          <c:h val="0.56202137990676071"/>
        </c:manualLayout>
      </c:layout>
      <c:lineChart>
        <c:grouping val="standard"/>
        <c:varyColors val="0"/>
        <c:ser>
          <c:idx val="0"/>
          <c:order val="0"/>
          <c:tx>
            <c:strRef>
              <c:f>'binary cat acid'!$L$4</c:f>
              <c:strCache>
                <c:ptCount val="1"/>
                <c:pt idx="0">
                  <c:v>Pyelonephritis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accent6"/>
              </a:solidFill>
              <a:ln w="9525">
                <a:solidFill>
                  <a:schemeClr val="accent6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inary cat acid'!$M$16:$N$16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23</c:v>
                  </c:pt>
                </c:numCache>
              </c:numRef>
            </c:plus>
            <c:minus>
              <c:numRef>
                <c:f>'binary cat acid'!$M$16:$N$16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2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nary cat acid'!$M$3:$N$3</c:f>
              <c:strCache>
                <c:ptCount val="2"/>
                <c:pt idx="0">
                  <c:v>HCO3 ≤ 22</c:v>
                </c:pt>
                <c:pt idx="1">
                  <c:v>HCO3 &gt;22</c:v>
                </c:pt>
              </c:strCache>
            </c:strRef>
          </c:cat>
          <c:val>
            <c:numRef>
              <c:f>'binary cat acid'!$M$4:$N$4</c:f>
              <c:numCache>
                <c:formatCode>0.00</c:formatCode>
                <c:ptCount val="2"/>
                <c:pt idx="0">
                  <c:v>2.4300000000000002</c:v>
                </c:pt>
                <c:pt idx="1">
                  <c:v>1.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863-194F-A1C6-21A46F0A641E}"/>
            </c:ext>
          </c:extLst>
        </c:ser>
        <c:ser>
          <c:idx val="1"/>
          <c:order val="1"/>
          <c:tx>
            <c:strRef>
              <c:f>'binary cat acid'!$L$5</c:f>
              <c:strCache>
                <c:ptCount val="1"/>
                <c:pt idx="0">
                  <c:v>Pneumonia</c:v>
                </c:pt>
              </c:strCache>
            </c:strRef>
          </c:tx>
          <c:spPr>
            <a:ln w="22225" cap="rnd">
              <a:solidFill>
                <a:srgbClr val="CC0066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CC0066"/>
              </a:solidFill>
              <a:ln w="9525">
                <a:solidFill>
                  <a:srgbClr val="CC0066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inary cat acid'!$M$17:$N$17</c:f>
                <c:numCache>
                  <c:formatCode>General</c:formatCode>
                  <c:ptCount val="2"/>
                  <c:pt idx="0">
                    <c:v>0.18</c:v>
                  </c:pt>
                  <c:pt idx="1">
                    <c:v>0.16</c:v>
                  </c:pt>
                </c:numCache>
              </c:numRef>
            </c:plus>
            <c:minus>
              <c:numRef>
                <c:f>'binary cat acid'!$M$17:$N$17</c:f>
                <c:numCache>
                  <c:formatCode>General</c:formatCode>
                  <c:ptCount val="2"/>
                  <c:pt idx="0">
                    <c:v>0.18</c:v>
                  </c:pt>
                  <c:pt idx="1">
                    <c:v>0.1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nary cat acid'!$M$3:$N$3</c:f>
              <c:strCache>
                <c:ptCount val="2"/>
                <c:pt idx="0">
                  <c:v>HCO3 ≤ 22</c:v>
                </c:pt>
                <c:pt idx="1">
                  <c:v>HCO3 &gt;22</c:v>
                </c:pt>
              </c:strCache>
            </c:strRef>
          </c:cat>
          <c:val>
            <c:numRef>
              <c:f>'binary cat acid'!$M$5:$N$5</c:f>
              <c:numCache>
                <c:formatCode>0.00</c:formatCode>
                <c:ptCount val="2"/>
                <c:pt idx="0">
                  <c:v>1.92</c:v>
                </c:pt>
                <c:pt idx="1">
                  <c:v>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863-194F-A1C6-21A46F0A64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21729312"/>
        <c:axId val="1723469376"/>
      </c:lineChart>
      <c:catAx>
        <c:axId val="17217293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rgbClr val="00206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aseline="0" dirty="0">
                    <a:solidFill>
                      <a:srgbClr val="002060"/>
                    </a:solidFill>
                  </a:rPr>
                  <a:t>Nadir BICARBONATE</a:t>
                </a:r>
              </a:p>
            </c:rich>
          </c:tx>
          <c:layout>
            <c:manualLayout>
              <c:xMode val="edge"/>
              <c:yMode val="edge"/>
              <c:x val="0.39282444824739265"/>
              <c:y val="0.902326614575966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rgbClr val="00206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chemeClr val="accent1">
                    <a:lumMod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23469376"/>
        <c:crosses val="autoZero"/>
        <c:auto val="1"/>
        <c:lblAlgn val="ctr"/>
        <c:lblOffset val="100"/>
        <c:noMultiLvlLbl val="0"/>
      </c:catAx>
      <c:valAx>
        <c:axId val="1723469376"/>
        <c:scaling>
          <c:orientation val="minMax"/>
          <c:min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rgbClr val="00206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aseline="0" dirty="0">
                    <a:solidFill>
                      <a:srgbClr val="002060"/>
                    </a:solidFill>
                  </a:rPr>
                  <a:t>Fever Days</a:t>
                </a:r>
              </a:p>
            </c:rich>
          </c:tx>
          <c:layout>
            <c:manualLayout>
              <c:xMode val="edge"/>
              <c:yMode val="edge"/>
              <c:x val="9.1136846034372051E-3"/>
              <c:y val="0.326129688647459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rgbClr val="00206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217293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9229207064204798"/>
          <c:y val="0.1016471128772122"/>
          <c:w val="0.72423340209907572"/>
          <c:h val="0.133226470418192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accent1">
                  <a:lumMod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rgbClr val="002060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cap="all" spc="120" normalizeH="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r>
              <a:rPr lang="en-US" sz="1200" baseline="0" dirty="0">
                <a:solidFill>
                  <a:srgbClr val="002060"/>
                </a:solidFill>
              </a:rPr>
              <a:t>Hospital LOS</a:t>
            </a:r>
          </a:p>
        </c:rich>
      </c:tx>
      <c:layout>
        <c:manualLayout>
          <c:xMode val="edge"/>
          <c:yMode val="edge"/>
          <c:x val="0.36331972074691027"/>
          <c:y val="6.1467306894647453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cap="all" spc="120" normalizeH="0" baseline="0">
              <a:solidFill>
                <a:srgbClr val="00206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025807863528543"/>
          <c:y val="0.24192660803556776"/>
          <c:w val="0.80185945699997963"/>
          <c:h val="0.55193131314459065"/>
        </c:manualLayout>
      </c:layout>
      <c:lineChart>
        <c:grouping val="standard"/>
        <c:varyColors val="0"/>
        <c:ser>
          <c:idx val="0"/>
          <c:order val="0"/>
          <c:tx>
            <c:strRef>
              <c:f>'binary cat acid'!$L$10</c:f>
              <c:strCache>
                <c:ptCount val="1"/>
                <c:pt idx="0">
                  <c:v>Pyelonephritis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accent6"/>
              </a:solidFill>
              <a:ln w="9525">
                <a:solidFill>
                  <a:schemeClr val="accent6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inary cat acid'!$M$22:$N$22</c:f>
                <c:numCache>
                  <c:formatCode>General</c:formatCode>
                  <c:ptCount val="2"/>
                  <c:pt idx="0">
                    <c:v>0.16</c:v>
                  </c:pt>
                  <c:pt idx="1">
                    <c:v>0.19</c:v>
                  </c:pt>
                </c:numCache>
              </c:numRef>
            </c:plus>
            <c:minus>
              <c:numRef>
                <c:f>'binary cat acid'!$M$22:$N$22</c:f>
                <c:numCache>
                  <c:formatCode>General</c:formatCode>
                  <c:ptCount val="2"/>
                  <c:pt idx="0">
                    <c:v>0.16</c:v>
                  </c:pt>
                  <c:pt idx="1">
                    <c:v>0.1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nary cat acid'!$M$9:$N$9</c:f>
              <c:strCache>
                <c:ptCount val="2"/>
                <c:pt idx="0">
                  <c:v>HCO3 ≤ 22</c:v>
                </c:pt>
                <c:pt idx="1">
                  <c:v>HCO3 &gt;22</c:v>
                </c:pt>
              </c:strCache>
            </c:strRef>
          </c:cat>
          <c:val>
            <c:numRef>
              <c:f>'binary cat acid'!$M$10:$N$10</c:f>
              <c:numCache>
                <c:formatCode>0.00</c:formatCode>
                <c:ptCount val="2"/>
                <c:pt idx="0">
                  <c:v>3.8</c:v>
                </c:pt>
                <c:pt idx="1">
                  <c:v>3.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E4E-8A4F-A18B-337023617D4F}"/>
            </c:ext>
          </c:extLst>
        </c:ser>
        <c:ser>
          <c:idx val="1"/>
          <c:order val="1"/>
          <c:tx>
            <c:strRef>
              <c:f>'binary cat acid'!$L$11</c:f>
              <c:strCache>
                <c:ptCount val="1"/>
                <c:pt idx="0">
                  <c:v>Pneumonia</c:v>
                </c:pt>
              </c:strCache>
            </c:strRef>
          </c:tx>
          <c:spPr>
            <a:ln w="22225" cap="rnd">
              <a:solidFill>
                <a:srgbClr val="CC0066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CC0066"/>
              </a:solidFill>
              <a:ln w="9525">
                <a:solidFill>
                  <a:srgbClr val="CC0066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inary cat acid'!$M$23:$N$23</c:f>
                <c:numCache>
                  <c:formatCode>General</c:formatCode>
                  <c:ptCount val="2"/>
                  <c:pt idx="0">
                    <c:v>0.28000000000000003</c:v>
                  </c:pt>
                  <c:pt idx="1">
                    <c:v>0.19</c:v>
                  </c:pt>
                </c:numCache>
              </c:numRef>
            </c:plus>
            <c:minus>
              <c:numRef>
                <c:f>'binary cat acid'!$M$23:$N$23</c:f>
                <c:numCache>
                  <c:formatCode>General</c:formatCode>
                  <c:ptCount val="2"/>
                  <c:pt idx="0">
                    <c:v>0.28000000000000003</c:v>
                  </c:pt>
                  <c:pt idx="1">
                    <c:v>0.1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nary cat acid'!$M$9:$N$9</c:f>
              <c:strCache>
                <c:ptCount val="2"/>
                <c:pt idx="0">
                  <c:v>HCO3 ≤ 22</c:v>
                </c:pt>
                <c:pt idx="1">
                  <c:v>HCO3 &gt;22</c:v>
                </c:pt>
              </c:strCache>
            </c:strRef>
          </c:cat>
          <c:val>
            <c:numRef>
              <c:f>'binary cat acid'!$M$11:$N$11</c:f>
              <c:numCache>
                <c:formatCode>0.00</c:formatCode>
                <c:ptCount val="2"/>
                <c:pt idx="0">
                  <c:v>4.21</c:v>
                </c:pt>
                <c:pt idx="1">
                  <c:v>3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E4E-8A4F-A18B-337023617D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21718912"/>
        <c:axId val="1505776592"/>
      </c:lineChart>
      <c:catAx>
        <c:axId val="17217189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rgbClr val="00206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aseline="0" dirty="0">
                    <a:solidFill>
                      <a:srgbClr val="002060"/>
                    </a:solidFill>
                  </a:rPr>
                  <a:t>Nadir BICARBONATE</a:t>
                </a:r>
              </a:p>
            </c:rich>
          </c:tx>
          <c:layout>
            <c:manualLayout>
              <c:xMode val="edge"/>
              <c:yMode val="edge"/>
              <c:x val="0.37171660935883771"/>
              <c:y val="0.89867008179309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rgbClr val="00206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05776592"/>
        <c:crosses val="autoZero"/>
        <c:auto val="1"/>
        <c:lblAlgn val="ctr"/>
        <c:lblOffset val="100"/>
        <c:noMultiLvlLbl val="0"/>
      </c:catAx>
      <c:valAx>
        <c:axId val="1505776592"/>
        <c:scaling>
          <c:orientation val="minMax"/>
          <c:min val="2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all" baseline="0">
                    <a:solidFill>
                      <a:srgbClr val="00206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aseline="0" dirty="0">
                    <a:solidFill>
                      <a:srgbClr val="002060"/>
                    </a:solidFill>
                  </a:rPr>
                  <a:t>Hospital LO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all" baseline="0">
                  <a:solidFill>
                    <a:srgbClr val="00206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rgbClr val="00206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217189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1949583872406518"/>
          <c:y val="0.10184299622040772"/>
          <c:w val="0.81725076333683444"/>
          <c:h val="0.126029758888438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rgbClr val="00206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rgbClr val="00437A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FDAF70-BD43-458B-9706-189D7558FB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3D39B2-028F-4C66-A4BA-9636AB2065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939C6F-E0AC-43DF-AF0B-03E639DBC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FF17FF-66C0-49E2-B936-C19541439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C37288-CB79-4A8D-8B55-DF88A50B5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5105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FE33A-5716-48A7-92F8-F577D0FF98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5213D3-7DA3-4721-A25E-E5C5C56E2F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01631C-537B-43EA-B04B-BA1C2D48F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44EABD-E7B6-4F7A-9DB6-00615797A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98753-A83B-4C08-BEB3-F18734EDA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3318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2FF9B9-D84F-4FA4-84F5-4474710CFA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D80A57-3B1E-401A-9C1C-726BEF9DC4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BC402-1B66-48E6-8D23-F82904015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0E430-21B3-42AD-A137-D91E6C0AF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0056D-E537-4DE2-8526-AC0EE1120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66621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30323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31DD3D-B0A2-4353-AB24-AA17DF7C90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6E0FCC-3306-4749-8AAC-3A3B3FA3CB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824321-6DF0-4667-9A02-21A510B87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D8C079-FD29-4821-8F8A-5858FDD99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91AD69-3315-4FEC-B4E0-D585778BE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0527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246F68-691C-49C8-B1B3-FB46A2636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B006E0-169C-4D3F-AB18-259C83BD23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92AFB-A78B-4657-82C4-57CED536C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EE42E-8261-4322-B9A5-A44542BD4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F708E-C55D-445D-A47F-E26B4DBCD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5280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970D0-6125-4D0D-AA71-F2234C40A1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1F3EF-2CD6-4579-B6E9-9C82EB4A6C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ED0920-F180-4A08-B937-F61BCC6CAE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AE205F-D0FB-46C4-9D98-203495B51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A49A6B-398C-4F61-A18C-5E2AE2094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38AA06-236B-452C-86C5-08D389A39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8462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42CC5E-2C1F-4A51-AEB1-6C7A314A16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F9AADF-ACA1-4BA7-9670-A332BF170F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A25366-1A60-476A-A57F-7082E9BF73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54F334-F816-48EE-BE75-2E8A0FDBF3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39B453-BFA7-4A61-AF68-44143DFAFE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0127A0-ADD5-47E8-BE5E-73137DC36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846678-4B83-4BC2-AB5B-CAD4D05DF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39C212-FFE6-432D-B24F-6DB8C5B46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7168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88232-AC42-437D-93D5-9B3C2F209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D19E63-7BD0-49D8-8C85-EAF9D6B9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5E20C9-97D5-4ECA-BBEC-496B79D0C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09CB07-965D-428F-87F7-C931DF9CA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7903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133AEF-240F-4B7F-B11A-6916C2147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F35DAB5-FB01-4EDD-90A9-48A1BEEEE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96DE2D-049F-4E6A-BE39-57AE49950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14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E7021-D61C-4690-BC4C-4CABB20CDD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10E30D-9420-4E2F-9BDB-2CD1A62032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C07EBE-C42B-42F2-9C47-1A5FD4A750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551046-B8E2-416A-93A4-ED7C45B2A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B0ED82-CC6E-4A45-A4EF-3FE6B2332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580B30-0585-46A2-BAA6-FADAA5965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4632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9B4AB-54A7-44F7-8FEB-E378DC64B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4A69AA-09FB-4963-85CB-55C3B5C2CA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06CB6B-084D-43A0-BC14-2C66BFEC0F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AB3A2E-6E78-4B42-95DC-27DAB0EF8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B5BE79-C585-40B7-BA8B-E408A25B9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149D63-18CD-47D3-958C-E8B7A03AB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3874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EFACFC-3129-48C9-B517-88FECC0CC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FCA484-4934-4C14-B0EA-18ED8BA366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2D03A0-FD92-4C59-AB65-27519C27A9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FD094-DE1F-4DF1-BC37-CAD5DAC91A6D}" type="datetimeFigureOut">
              <a:rPr lang="en-US" smtClean="0"/>
              <a:t>1/28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2C788E-6AE6-405B-AED9-5AEA995B94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522775-1BA0-40B2-B839-AE3F1C66C2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86ADC-F225-4729-AE2B-D94BC3600CA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58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Metabolic acidosis is associated with infection severity in pediatric pyelonephritis and pneumoni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3448" y="1048969"/>
            <a:ext cx="105362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ssess if children 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with acute pyelonephritis develop a transient metabolic acidosis, and if a lower nadir serum bicarbonate is associated with greater infection severity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rumme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5985" y="5797174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Most pediatric patients with pyelonephritis developed a metabolic acidosis. There was a statistically significant association between acidosis and both number of fever days and hospital length of stay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542F28F-0212-49F4-B167-673C32747062}"/>
              </a:ext>
            </a:extLst>
          </p:cNvPr>
          <p:cNvSpPr txBox="1"/>
          <p:nvPr/>
        </p:nvSpPr>
        <p:spPr>
          <a:xfrm>
            <a:off x="15618" y="2641764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Pyelonephritis</a:t>
            </a: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n = 9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8F1BC5-5C52-DBF0-08D7-ACD2472430D4}"/>
              </a:ext>
            </a:extLst>
          </p:cNvPr>
          <p:cNvSpPr txBox="1"/>
          <p:nvPr/>
        </p:nvSpPr>
        <p:spPr>
          <a:xfrm>
            <a:off x="20208" y="3933660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Pneumonia</a:t>
            </a: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n = 95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5690C65-5F8D-B069-CDC7-1F2D80AD63F9}"/>
              </a:ext>
            </a:extLst>
          </p:cNvPr>
          <p:cNvGrpSpPr/>
          <p:nvPr/>
        </p:nvGrpSpPr>
        <p:grpSpPr>
          <a:xfrm>
            <a:off x="1676420" y="2402756"/>
            <a:ext cx="1112039" cy="1088931"/>
            <a:chOff x="341276" y="2540150"/>
            <a:chExt cx="1242294" cy="1216480"/>
          </a:xfrm>
        </p:grpSpPr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8956E7CE-4F53-DB68-627F-E0F8B9D1D65C}"/>
                </a:ext>
              </a:extLst>
            </p:cNvPr>
            <p:cNvSpPr/>
            <p:nvPr/>
          </p:nvSpPr>
          <p:spPr>
            <a:xfrm>
              <a:off x="341276" y="2540150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5CF6B2E-938D-624E-82AD-9BCCA199E40A}"/>
                </a:ext>
              </a:extLst>
            </p:cNvPr>
            <p:cNvGrpSpPr/>
            <p:nvPr/>
          </p:nvGrpSpPr>
          <p:grpSpPr>
            <a:xfrm>
              <a:off x="557002" y="2540150"/>
              <a:ext cx="1026568" cy="1216480"/>
              <a:chOff x="597918" y="2540150"/>
              <a:chExt cx="1026568" cy="1216480"/>
            </a:xfrm>
          </p:grpSpPr>
          <p:sp>
            <p:nvSpPr>
              <p:cNvPr id="8" name="Freeform: Shape 46">
                <a:extLst>
                  <a:ext uri="{FF2B5EF4-FFF2-40B4-BE49-F238E27FC236}">
                    <a16:creationId xmlns:a16="http://schemas.microsoft.com/office/drawing/2014/main" id="{5A8908A3-0C14-24E5-F8E6-65BAFD1EC844}"/>
                  </a:ext>
                </a:extLst>
              </p:cNvPr>
              <p:cNvSpPr/>
              <p:nvPr/>
            </p:nvSpPr>
            <p:spPr>
              <a:xfrm>
                <a:off x="1111202" y="2706732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chemeClr val="accent1">
                  <a:lumMod val="50000"/>
                </a:schemeClr>
              </a:solidFill>
              <a:ln w="15081" cap="flat">
                <a:solidFill>
                  <a:schemeClr val="accent1">
                    <a:lumMod val="50000"/>
                  </a:schemeClr>
                </a:solidFill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9" name="Freeform: Shape 46">
                <a:extLst>
                  <a:ext uri="{FF2B5EF4-FFF2-40B4-BE49-F238E27FC236}">
                    <a16:creationId xmlns:a16="http://schemas.microsoft.com/office/drawing/2014/main" id="{A7EA4FB3-3ACE-FB66-B86F-29A5DA21A105}"/>
                  </a:ext>
                </a:extLst>
              </p:cNvPr>
              <p:cNvSpPr/>
              <p:nvPr/>
            </p:nvSpPr>
            <p:spPr>
              <a:xfrm>
                <a:off x="597918" y="2706732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chemeClr val="accent6"/>
              </a:solidFill>
              <a:ln w="15081" cap="flat">
                <a:solidFill>
                  <a:schemeClr val="accent6"/>
                </a:solidFill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10" name="Freeform: Shape 46">
                <a:extLst>
                  <a:ext uri="{FF2B5EF4-FFF2-40B4-BE49-F238E27FC236}">
                    <a16:creationId xmlns:a16="http://schemas.microsoft.com/office/drawing/2014/main" id="{71DE8001-7E75-92AF-1E60-0DFDC4213249}"/>
                  </a:ext>
                </a:extLst>
              </p:cNvPr>
              <p:cNvSpPr/>
              <p:nvPr/>
            </p:nvSpPr>
            <p:spPr>
              <a:xfrm>
                <a:off x="854560" y="254015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CC0066"/>
              </a:solidFill>
              <a:ln w="15081" cap="flat">
                <a:solidFill>
                  <a:srgbClr val="CC0066"/>
                </a:solidFill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1C707238-1D6E-7685-3E60-94D13B4BF77F}"/>
              </a:ext>
            </a:extLst>
          </p:cNvPr>
          <p:cNvGrpSpPr/>
          <p:nvPr/>
        </p:nvGrpSpPr>
        <p:grpSpPr>
          <a:xfrm>
            <a:off x="1579867" y="4043148"/>
            <a:ext cx="1112039" cy="1088931"/>
            <a:chOff x="341276" y="2540150"/>
            <a:chExt cx="1242294" cy="1216480"/>
          </a:xfrm>
        </p:grpSpPr>
        <p:sp>
          <p:nvSpPr>
            <p:cNvPr id="12" name="Freeform: Shape 46">
              <a:extLst>
                <a:ext uri="{FF2B5EF4-FFF2-40B4-BE49-F238E27FC236}">
                  <a16:creationId xmlns:a16="http://schemas.microsoft.com/office/drawing/2014/main" id="{5CF2B779-671F-73A9-A5F2-0F02338A0E4B}"/>
                </a:ext>
              </a:extLst>
            </p:cNvPr>
            <p:cNvSpPr/>
            <p:nvPr/>
          </p:nvSpPr>
          <p:spPr>
            <a:xfrm>
              <a:off x="341276" y="2540150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752528BD-D0A8-0F84-B878-A98B4E4C136E}"/>
                </a:ext>
              </a:extLst>
            </p:cNvPr>
            <p:cNvGrpSpPr/>
            <p:nvPr/>
          </p:nvGrpSpPr>
          <p:grpSpPr>
            <a:xfrm>
              <a:off x="557002" y="2540150"/>
              <a:ext cx="1026568" cy="1216480"/>
              <a:chOff x="597918" y="2540150"/>
              <a:chExt cx="1026568" cy="1216480"/>
            </a:xfrm>
          </p:grpSpPr>
          <p:sp>
            <p:nvSpPr>
              <p:cNvPr id="14" name="Freeform: Shape 46">
                <a:extLst>
                  <a:ext uri="{FF2B5EF4-FFF2-40B4-BE49-F238E27FC236}">
                    <a16:creationId xmlns:a16="http://schemas.microsoft.com/office/drawing/2014/main" id="{030F3C90-AB6F-1DD8-7A60-CD3B97B5D185}"/>
                  </a:ext>
                </a:extLst>
              </p:cNvPr>
              <p:cNvSpPr/>
              <p:nvPr/>
            </p:nvSpPr>
            <p:spPr>
              <a:xfrm>
                <a:off x="1111202" y="2706732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chemeClr val="accent1">
                  <a:lumMod val="50000"/>
                </a:schemeClr>
              </a:solidFill>
              <a:ln w="15081" cap="flat">
                <a:solidFill>
                  <a:schemeClr val="accent1">
                    <a:lumMod val="50000"/>
                  </a:schemeClr>
                </a:solidFill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15" name="Freeform: Shape 46">
                <a:extLst>
                  <a:ext uri="{FF2B5EF4-FFF2-40B4-BE49-F238E27FC236}">
                    <a16:creationId xmlns:a16="http://schemas.microsoft.com/office/drawing/2014/main" id="{5F38B567-C897-5EA9-2EDC-DD96C53F1E48}"/>
                  </a:ext>
                </a:extLst>
              </p:cNvPr>
              <p:cNvSpPr/>
              <p:nvPr/>
            </p:nvSpPr>
            <p:spPr>
              <a:xfrm>
                <a:off x="597918" y="2706732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chemeClr val="accent6"/>
              </a:solidFill>
              <a:ln w="15081" cap="flat">
                <a:solidFill>
                  <a:schemeClr val="accent6"/>
                </a:solidFill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16" name="Freeform: Shape 46">
                <a:extLst>
                  <a:ext uri="{FF2B5EF4-FFF2-40B4-BE49-F238E27FC236}">
                    <a16:creationId xmlns:a16="http://schemas.microsoft.com/office/drawing/2014/main" id="{B7D73605-7125-5EB8-C95E-0BFE35CD85D0}"/>
                  </a:ext>
                </a:extLst>
              </p:cNvPr>
              <p:cNvSpPr/>
              <p:nvPr/>
            </p:nvSpPr>
            <p:spPr>
              <a:xfrm>
                <a:off x="854560" y="2540150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CC0066"/>
              </a:solidFill>
              <a:ln w="15081" cap="flat">
                <a:solidFill>
                  <a:srgbClr val="CC0066"/>
                </a:solidFill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</p:grp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CE88C63-8228-50CA-6C64-797CA11F0FCE}"/>
              </a:ext>
            </a:extLst>
          </p:cNvPr>
          <p:cNvCxnSpPr>
            <a:cxnSpLocks/>
          </p:cNvCxnSpPr>
          <p:nvPr/>
        </p:nvCxnSpPr>
        <p:spPr>
          <a:xfrm flipV="1">
            <a:off x="2689689" y="3147785"/>
            <a:ext cx="537216" cy="63535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9FCDC30F-21D9-18D0-9DFD-87DA7D247C00}"/>
              </a:ext>
            </a:extLst>
          </p:cNvPr>
          <p:cNvCxnSpPr>
            <a:cxnSpLocks/>
          </p:cNvCxnSpPr>
          <p:nvPr/>
        </p:nvCxnSpPr>
        <p:spPr>
          <a:xfrm>
            <a:off x="2688712" y="3945154"/>
            <a:ext cx="557223" cy="62977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B14257FC-7141-A628-3344-8CCCD1BAE141}"/>
              </a:ext>
            </a:extLst>
          </p:cNvPr>
          <p:cNvSpPr/>
          <p:nvPr/>
        </p:nvSpPr>
        <p:spPr>
          <a:xfrm>
            <a:off x="3378888" y="1883136"/>
            <a:ext cx="2975830" cy="126465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Serum bicarbonate, anion gap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Baselin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Nadi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Recovery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68A265A-E1B1-03D7-8DFB-8D250F993422}"/>
              </a:ext>
            </a:extLst>
          </p:cNvPr>
          <p:cNvSpPr/>
          <p:nvPr/>
        </p:nvSpPr>
        <p:spPr>
          <a:xfrm>
            <a:off x="3341285" y="3932055"/>
            <a:ext cx="1960417" cy="1411652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Markers of Infection Sever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# of fever day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Hospital length of stay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544D7B60-0DB4-3D43-30C3-E02782431DD9}"/>
              </a:ext>
            </a:extLst>
          </p:cNvPr>
          <p:cNvCxnSpPr>
            <a:cxnSpLocks/>
          </p:cNvCxnSpPr>
          <p:nvPr/>
        </p:nvCxnSpPr>
        <p:spPr>
          <a:xfrm flipV="1">
            <a:off x="6627224" y="2516333"/>
            <a:ext cx="931817" cy="668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293A294D-223D-7955-C451-DF1CB1EC540C}"/>
              </a:ext>
            </a:extLst>
          </p:cNvPr>
          <p:cNvCxnSpPr>
            <a:cxnSpLocks/>
          </p:cNvCxnSpPr>
          <p:nvPr/>
        </p:nvCxnSpPr>
        <p:spPr>
          <a:xfrm>
            <a:off x="5353956" y="4599897"/>
            <a:ext cx="345798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B632B79-002D-7EB9-D1A2-3E21AE5089F9}"/>
              </a:ext>
            </a:extLst>
          </p:cNvPr>
          <p:cNvGrpSpPr/>
          <p:nvPr/>
        </p:nvGrpSpPr>
        <p:grpSpPr>
          <a:xfrm>
            <a:off x="7831547" y="1953679"/>
            <a:ext cx="3812184" cy="1099409"/>
            <a:chOff x="7679856" y="2291616"/>
            <a:chExt cx="4076469" cy="1175627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5289614B-6B41-AA02-4D37-1170B968F13F}"/>
                </a:ext>
              </a:extLst>
            </p:cNvPr>
            <p:cNvSpPr/>
            <p:nvPr/>
          </p:nvSpPr>
          <p:spPr>
            <a:xfrm>
              <a:off x="9250542" y="2678677"/>
              <a:ext cx="1311775" cy="399786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20 (3)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DF22E34B-A3E3-1836-A40E-45D1A5276CC9}"/>
                </a:ext>
              </a:extLst>
            </p:cNvPr>
            <p:cNvSpPr/>
            <p:nvPr/>
          </p:nvSpPr>
          <p:spPr>
            <a:xfrm>
              <a:off x="10555852" y="2674045"/>
              <a:ext cx="1200473" cy="407445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16 (4) 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8D639AB0-9210-7218-264B-C1B1B3DC2FA4}"/>
                </a:ext>
              </a:extLst>
            </p:cNvPr>
            <p:cNvSpPr/>
            <p:nvPr/>
          </p:nvSpPr>
          <p:spPr>
            <a:xfrm>
              <a:off x="7679857" y="2294968"/>
              <a:ext cx="1570687" cy="379423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b="1" u="sng" dirty="0">
                  <a:solidFill>
                    <a:srgbClr val="00437A"/>
                  </a:solidFill>
                </a:rPr>
                <a:t>Nadir</a:t>
              </a:r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02F69D27-8826-0FDB-7B7C-FFC2858238BB}"/>
                </a:ext>
              </a:extLst>
            </p:cNvPr>
            <p:cNvSpPr/>
            <p:nvPr/>
          </p:nvSpPr>
          <p:spPr>
            <a:xfrm>
              <a:off x="7679856" y="2682095"/>
              <a:ext cx="1568742" cy="400110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Pyelonephritis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2F60E2CE-C69B-34F5-6392-E6D397752E70}"/>
                </a:ext>
              </a:extLst>
            </p:cNvPr>
            <p:cNvSpPr/>
            <p:nvPr/>
          </p:nvSpPr>
          <p:spPr>
            <a:xfrm>
              <a:off x="7679857" y="3076739"/>
              <a:ext cx="1578382" cy="389176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Pneumonia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8D9462C2-C9E0-F1DF-CCF8-0752FFC0E4AC}"/>
                </a:ext>
              </a:extLst>
            </p:cNvPr>
            <p:cNvSpPr/>
            <p:nvPr/>
          </p:nvSpPr>
          <p:spPr>
            <a:xfrm>
              <a:off x="9244077" y="2292223"/>
              <a:ext cx="1311775" cy="389176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>
                  <a:solidFill>
                    <a:srgbClr val="00437A"/>
                  </a:solidFill>
                </a:rPr>
                <a:t>Bicarbonate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4EF55113-927E-8F47-1FED-9D40F0F1F69A}"/>
                </a:ext>
              </a:extLst>
            </p:cNvPr>
            <p:cNvSpPr/>
            <p:nvPr/>
          </p:nvSpPr>
          <p:spPr>
            <a:xfrm>
              <a:off x="10558427" y="2291616"/>
              <a:ext cx="1197898" cy="389176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>
                  <a:solidFill>
                    <a:srgbClr val="00437A"/>
                  </a:solidFill>
                </a:rPr>
                <a:t>Anion gap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744B2BB-43B3-C8AB-6684-5E8024E8D99C}"/>
                </a:ext>
              </a:extLst>
            </p:cNvPr>
            <p:cNvSpPr/>
            <p:nvPr/>
          </p:nvSpPr>
          <p:spPr>
            <a:xfrm>
              <a:off x="9264704" y="3080171"/>
              <a:ext cx="1299558" cy="385349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21 (3)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41159791-5735-BBF2-09BC-D044D3EFEAED}"/>
                </a:ext>
              </a:extLst>
            </p:cNvPr>
            <p:cNvSpPr/>
            <p:nvPr/>
          </p:nvSpPr>
          <p:spPr>
            <a:xfrm>
              <a:off x="10558427" y="3074345"/>
              <a:ext cx="1197898" cy="392898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17 (3)</a:t>
              </a:r>
            </a:p>
          </p:txBody>
        </p:sp>
      </p:grpSp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06F9A797-2A06-D590-9A54-CCA794E989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4101709"/>
              </p:ext>
            </p:extLst>
          </p:nvPr>
        </p:nvGraphicFramePr>
        <p:xfrm>
          <a:off x="5727186" y="3338458"/>
          <a:ext cx="3161290" cy="2106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6C205882-F355-7A96-17AC-AD1E71CF50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3095690"/>
              </p:ext>
            </p:extLst>
          </p:nvPr>
        </p:nvGraphicFramePr>
        <p:xfrm>
          <a:off x="8930409" y="3338458"/>
          <a:ext cx="3161290" cy="21068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981638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142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mmer, Hannah</dc:creator>
  <cp:lastModifiedBy>Bob Thompson</cp:lastModifiedBy>
  <cp:revision>21</cp:revision>
  <dcterms:created xsi:type="dcterms:W3CDTF">2024-04-30T19:59:20Z</dcterms:created>
  <dcterms:modified xsi:type="dcterms:W3CDTF">2025-01-29T00:27:31Z</dcterms:modified>
</cp:coreProperties>
</file>